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D1013B-6FDF-43F9-A3D0-1C1CA88BD72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C2BEC5-32D0-4CF7-88A6-C04B5E0605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A0667D-E67C-4279-B1EA-867DBB0182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2E6C52-16F9-4BDD-842C-BD83B3FC188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9DA34-A8AA-4A8D-9310-FA8D796279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E8890E-C607-4F0D-9F8B-0C68C4AA8B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5B566B-DBB4-4596-8339-0174F3B4ED0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6850ED-923A-4A85-B88D-884CD4F1D3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3C689D-FA68-4694-A3B2-E017D3B330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EEE75-95E6-4BC1-A0B5-2B113F0F49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5D1D3-5A1A-460A-B12C-F863239281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3F4E1B-4254-4971-BB22-6F0042656A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3FCEE6-A5B3-4707-8CA7-880EA0FF7AB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33520" y="57146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6: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Adjusting for smoking habit or use of betel leaf did not show any effect on the HR of the genomic segments (adjusted for gender, age &amp; UACR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2057400" y="228600"/>
            <a:ext cx="4767120" cy="5410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1-23T22:36:52Z</dcterms:created>
  <dc:creator>mkibriya</dc:creator>
  <dc:description/>
  <dc:language>en-US</dc:language>
  <cp:lastModifiedBy>mkibriya</cp:lastModifiedBy>
  <dcterms:modified xsi:type="dcterms:W3CDTF">2017-03-29T18:45:19Z</dcterms:modified>
  <cp:revision>37</cp:revision>
  <dc:subject/>
  <dc:title>Slide 1</dc:title>
</cp:coreProperties>
</file>